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D4E810-E078-4D9D-A71C-5ED1CA187B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6EA7C4-B0F4-418D-918B-2EB3C7361E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F39DF6-DEB8-42CF-A693-FCFF128C03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AA7D1-27F4-4399-B483-B718B0C6711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30E9F2-52C7-4A76-9B6E-A27257F4B0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B3C9F8-6634-41A8-A334-854C5DB15B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4CC424-F5D5-4392-B998-A1BD39C6A3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A25B35-CE5C-4C07-8768-0A3D29D5C3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C9C85E-D4DC-4CCF-A116-0506CDB621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A01386-A339-4AC9-A467-D5747AA1CE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4106C4-6F9A-433D-983D-CCF3C6C56E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7F72B8-307D-483D-B50B-568F0D9FE6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A786CAA-3CC4-4C2E-987D-BE176E542399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187280" y="1797120"/>
          <a:ext cx="6697800" cy="3003480"/>
        </p:xfrm>
        <a:graphic>
          <a:graphicData uri="http://schemas.openxmlformats.org/drawingml/2006/table">
            <a:tbl>
              <a:tblPr/>
              <a:tblGrid>
                <a:gridCol w="1033560"/>
                <a:gridCol w="1033560"/>
                <a:gridCol w="1174680"/>
                <a:gridCol w="1362240"/>
                <a:gridCol w="1046160"/>
                <a:gridCol w="1047600"/>
              </a:tblGrid>
              <a:tr h="622080">
                <a:tc gridSpan="6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Serum level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970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Lepti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Adiponecti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Triglyceride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Glucago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C-peptid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967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ng/ml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mg/ml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mg/dl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pg/ml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pM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970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967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C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0.7 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Arial"/>
                        </a:rPr>
                        <a:t>+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2.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45.2 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Arial"/>
                        </a:rPr>
                        <a:t>+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2.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58.4 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Arial"/>
                        </a:rPr>
                        <a:t>+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3.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51.8 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Arial"/>
                        </a:rPr>
                        <a:t>+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10.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40.7 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Arial"/>
                        </a:rPr>
                        <a:t>+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2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970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HF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96.7 + 23.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53.9 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Arial"/>
                        </a:rPr>
                        <a:t>+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11.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65.9 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Arial"/>
                        </a:rPr>
                        <a:t>+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6.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56.9 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Arial"/>
                        </a:rPr>
                        <a:t>+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11.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28.3 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Arial"/>
                        </a:rPr>
                        <a:t>+ 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8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967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HFD + Leu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70.4 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Arial"/>
                        </a:rPr>
                        <a:t>+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24.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48.8 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Arial"/>
                        </a:rPr>
                        <a:t>+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7.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62.1 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Arial"/>
                        </a:rPr>
                        <a:t>+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3.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56.6 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Arial"/>
                        </a:rPr>
                        <a:t>+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16.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74.6 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Arial"/>
                        </a:rPr>
                        <a:t>+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5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2 CuadroTexto"/>
          <p:cNvSpPr/>
          <p:nvPr/>
        </p:nvSpPr>
        <p:spPr>
          <a:xfrm>
            <a:off x="324000" y="476280"/>
            <a:ext cx="720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3T00:44:28Z</dcterms:created>
  <dc:creator>Yazmin Macotela</dc:creator>
  <dc:description/>
  <dc:language>en-US</dc:language>
  <cp:lastModifiedBy>Yazmin Macotela</cp:lastModifiedBy>
  <dcterms:modified xsi:type="dcterms:W3CDTF">2011-06-03T01:15:40Z</dcterms:modified>
  <cp:revision>2</cp:revision>
  <dc:subject/>
  <dc:title>Presentación de PowerPoint</dc:title>
</cp:coreProperties>
</file>